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218558-8922-45DE-99F5-41997F4429C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D3BEC6-7A6C-46A3-AF95-5464AE9BEC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CDDD72-4567-40CF-9656-13706A302CF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ECE5C7-D9F4-4AFD-93BA-EF04EE2C04E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B62D67-A85C-4BB5-8B9C-D7697C86B34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01F3DA-CECA-4FFF-8546-42CA21DB03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1F7F34-36CD-46A9-B445-F8DBFB6F028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04016B-743D-44A2-8933-5DE228EF9A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F935F7-FB97-4E35-BDFB-A2FAB7B5E1F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A4DA3F-D0FA-4058-A815-ECDFCA1B14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24988F-0D86-49F7-8C9E-B03B45FC29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F68966-F862-4495-B95B-AB196CA8B1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E745408-2F4B-45AD-85BE-49D5211C971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762120" y="304920"/>
            <a:ext cx="7812000" cy="100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A simple algebraic cancer equation: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calculating how cancers may arise with normal mutation rates </a:t>
            </a:r>
            <a:br>
              <a:rPr sz="2000"/>
            </a:b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Peter Calabrese &amp; Darryl Shibata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4"/>
          <p:cNvSpPr/>
          <p:nvPr/>
        </p:nvSpPr>
        <p:spPr>
          <a:xfrm>
            <a:off x="422640" y="1600200"/>
            <a:ext cx="8585640" cy="173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Question: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A fundamental question is whether human cancers may arise fro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relatively “normal” processes, specifically normal mutation and division rates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pproach: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ne can calculate the probability of cancer with a simple model. The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“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nswer” is provided by cancer epidemiology, or how often cancer arises in a singl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ell during a lifetime: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Picture 4" descr=""/>
          <p:cNvPicPr/>
          <p:nvPr/>
        </p:nvPicPr>
        <p:blipFill>
          <a:blip r:embed="rId1"/>
          <a:stretch/>
        </p:blipFill>
        <p:spPr>
          <a:xfrm>
            <a:off x="3171960" y="3352680"/>
            <a:ext cx="2543040" cy="1781280"/>
          </a:xfrm>
          <a:prstGeom prst="rect">
            <a:avLst/>
          </a:prstGeom>
          <a:ln w="0">
            <a:noFill/>
          </a:ln>
        </p:spPr>
      </p:pic>
      <p:sp>
        <p:nvSpPr>
          <p:cNvPr id="44" name="Text Box 9"/>
          <p:cNvSpPr/>
          <p:nvPr/>
        </p:nvSpPr>
        <p:spPr>
          <a:xfrm>
            <a:off x="4231440" y="4965840"/>
            <a:ext cx="866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ge at cance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 Box 11"/>
          <p:cNvSpPr/>
          <p:nvPr/>
        </p:nvSpPr>
        <p:spPr>
          <a:xfrm>
            <a:off x="3484800" y="3457440"/>
            <a:ext cx="113940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olorectal Cance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Epidemiolog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9"/>
          <p:cNvSpPr/>
          <p:nvPr/>
        </p:nvSpPr>
        <p:spPr>
          <a:xfrm>
            <a:off x="322560" y="5257800"/>
            <a:ext cx="876708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s seen above, the incidence of colorectal cancer increases with age. Although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epidemiology measures cancers in human populations, it is easy to convert thi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ata into cell populations. A human colon contains about 15 million crypts, an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each crypt has a least one long-lived stem cell lineage that may eventually transform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 Box 10"/>
          <p:cNvSpPr/>
          <p:nvPr/>
        </p:nvSpPr>
        <p:spPr>
          <a:xfrm rot="16200000">
            <a:off x="2190960" y="3945240"/>
            <a:ext cx="14914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rate per 100,00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individual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2"/>
          <p:cNvSpPr/>
          <p:nvPr/>
        </p:nvSpPr>
        <p:spPr>
          <a:xfrm>
            <a:off x="457200" y="304920"/>
            <a:ext cx="7812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Converting epidemiology to stem cell biology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Picture 4" descr=""/>
          <p:cNvPicPr/>
          <p:nvPr/>
        </p:nvPicPr>
        <p:blipFill>
          <a:blip r:embed="rId1"/>
          <a:stretch/>
        </p:blipFill>
        <p:spPr>
          <a:xfrm>
            <a:off x="1467000" y="1335240"/>
            <a:ext cx="2543040" cy="1780920"/>
          </a:xfrm>
          <a:prstGeom prst="rect">
            <a:avLst/>
          </a:prstGeom>
          <a:ln w="0">
            <a:noFill/>
          </a:ln>
        </p:spPr>
      </p:pic>
      <p:sp>
        <p:nvSpPr>
          <p:cNvPr id="50" name="Text Box 9"/>
          <p:cNvSpPr/>
          <p:nvPr/>
        </p:nvSpPr>
        <p:spPr>
          <a:xfrm>
            <a:off x="2526480" y="2948040"/>
            <a:ext cx="866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ge at cance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 Box 11"/>
          <p:cNvSpPr/>
          <p:nvPr/>
        </p:nvSpPr>
        <p:spPr>
          <a:xfrm>
            <a:off x="1779840" y="1440000"/>
            <a:ext cx="113940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olorectal Cance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Epidemiolog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2" name="Picture 4" descr=""/>
          <p:cNvPicPr/>
          <p:nvPr/>
        </p:nvPicPr>
        <p:blipFill>
          <a:blip r:embed="rId2"/>
          <a:stretch/>
        </p:blipFill>
        <p:spPr>
          <a:xfrm>
            <a:off x="5457960" y="1335240"/>
            <a:ext cx="2543040" cy="1780920"/>
          </a:xfrm>
          <a:prstGeom prst="rect">
            <a:avLst/>
          </a:prstGeom>
          <a:ln w="0">
            <a:noFill/>
          </a:ln>
        </p:spPr>
      </p:pic>
      <p:sp>
        <p:nvSpPr>
          <p:cNvPr id="53" name="Text Box 9"/>
          <p:cNvSpPr/>
          <p:nvPr/>
        </p:nvSpPr>
        <p:spPr>
          <a:xfrm>
            <a:off x="6517440" y="2948040"/>
            <a:ext cx="866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ge at cance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 Box 10"/>
          <p:cNvSpPr/>
          <p:nvPr/>
        </p:nvSpPr>
        <p:spPr>
          <a:xfrm rot="16200000">
            <a:off x="4398480" y="1844640"/>
            <a:ext cx="16286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rate per 1.5 X10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13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tem cell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 Box 11"/>
          <p:cNvSpPr/>
          <p:nvPr/>
        </p:nvSpPr>
        <p:spPr>
          <a:xfrm>
            <a:off x="5770800" y="1440000"/>
            <a:ext cx="113940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olorectal Cance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Epidemiolog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11"/>
          <p:cNvSpPr/>
          <p:nvPr/>
        </p:nvSpPr>
        <p:spPr>
          <a:xfrm>
            <a:off x="42480" y="685800"/>
            <a:ext cx="9189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Therefore the minimum number of stem cells at risk is 15,000,000 per person. For 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00,000 individual population, there are 15,000,000,000,000 stem cells at risk (1.5 x 10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13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Right Arrow 12"/>
          <p:cNvSpPr/>
          <p:nvPr/>
        </p:nvSpPr>
        <p:spPr>
          <a:xfrm>
            <a:off x="4267080" y="1752480"/>
            <a:ext cx="533520" cy="68580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13"/>
          <p:cNvSpPr/>
          <p:nvPr/>
        </p:nvSpPr>
        <p:spPr>
          <a:xfrm>
            <a:off x="47880" y="3240000"/>
            <a:ext cx="875772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There are likely a greater number of stem cells at risk for cancer because there are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likely multiple stem cells per human colon crypt. It is clear that only a small fraction of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t risk stem cells transform within a lifetime (a lifetime transformation efficiency of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~3 X 10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9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)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125"/>
          <p:cNvSpPr/>
          <p:nvPr/>
        </p:nvSpPr>
        <p:spPr>
          <a:xfrm>
            <a:off x="113040" y="4572000"/>
            <a:ext cx="9109800" cy="146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Intuition: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The probability that a single cell within an individual transforms likely depends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n a number of parameters. Transformation is more likely with greater number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f cells at risk, greater numbers of divisions, higher mutation rates, and fewer numbers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f required drivers (selective) mutations. The relative contributions of these risk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factors towards transformation can be formally related in the derived equation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 Box 10"/>
          <p:cNvSpPr/>
          <p:nvPr/>
        </p:nvSpPr>
        <p:spPr>
          <a:xfrm rot="16200000">
            <a:off x="505080" y="1859400"/>
            <a:ext cx="14914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rate per 100,00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individual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TextBox 1"/>
          <p:cNvSpPr/>
          <p:nvPr/>
        </p:nvSpPr>
        <p:spPr>
          <a:xfrm>
            <a:off x="457200" y="304920"/>
            <a:ext cx="7812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The equation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2"/>
          <p:cNvSpPr/>
          <p:nvPr/>
        </p:nvSpPr>
        <p:spPr>
          <a:xfrm>
            <a:off x="3018600" y="2666880"/>
            <a:ext cx="2605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= 1 - (1 - (1 - (1 -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u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)</a:t>
            </a:r>
            <a:r>
              <a:rPr b="0" i="1" lang="en-US" sz="1800" spc="-1" strike="noStrike" baseline="30000">
                <a:solidFill>
                  <a:srgbClr val="000000"/>
                </a:solidFill>
                <a:latin typeface="Calibri"/>
              </a:rPr>
              <a:t>d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)</a:t>
            </a:r>
            <a:r>
              <a:rPr b="0" i="1" lang="en-US" sz="1800" spc="-1" strike="noStrike" baseline="30000">
                <a:solidFill>
                  <a:srgbClr val="000000"/>
                </a:solidFill>
                <a:latin typeface="Calibri"/>
              </a:rPr>
              <a:t>k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)</a:t>
            </a:r>
            <a:r>
              <a:rPr b="0" i="1" lang="en-US" sz="1800" spc="-1" strike="noStrike" baseline="30000">
                <a:solidFill>
                  <a:srgbClr val="000000"/>
                </a:solidFill>
                <a:latin typeface="Calibri"/>
              </a:rPr>
              <a:t>N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3"/>
          <p:cNvSpPr/>
          <p:nvPr/>
        </p:nvSpPr>
        <p:spPr>
          <a:xfrm>
            <a:off x="-18000" y="2057400"/>
            <a:ext cx="91112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The equation uses the trick that the probability of “something” is 1 minus “not something”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see manuscript for details). The equation is: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4"/>
          <p:cNvSpPr/>
          <p:nvPr/>
        </p:nvSpPr>
        <p:spPr>
          <a:xfrm>
            <a:off x="293400" y="3048120"/>
            <a:ext cx="8698320" cy="173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p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is the probability that a single stem cell within an individual will transform after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divisions. The question is whether this equation can match the epidemiology of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ancer with reasonable or “normal” values for the mutation rate, cell division rate,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numbers of stem cells, and numbers of driver mutations. As illustrated below, th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equation can yield an cancer/age incidence curve similar to human colorectal cance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epidemiology with reasonable parameter values: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5" name="Picture 67" descr=""/>
          <p:cNvPicPr/>
          <p:nvPr/>
        </p:nvPicPr>
        <p:blipFill>
          <a:blip r:embed="rId1"/>
          <a:stretch/>
        </p:blipFill>
        <p:spPr>
          <a:xfrm>
            <a:off x="1066680" y="4870440"/>
            <a:ext cx="2543400" cy="1790640"/>
          </a:xfrm>
          <a:prstGeom prst="rect">
            <a:avLst/>
          </a:prstGeom>
          <a:ln w="0">
            <a:noFill/>
          </a:ln>
        </p:spPr>
      </p:pic>
      <p:sp>
        <p:nvSpPr>
          <p:cNvPr id="66" name="Text Box 9"/>
          <p:cNvSpPr/>
          <p:nvPr/>
        </p:nvSpPr>
        <p:spPr>
          <a:xfrm>
            <a:off x="1993320" y="6537240"/>
            <a:ext cx="866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ge at cance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 Box 10"/>
          <p:cNvSpPr/>
          <p:nvPr/>
        </p:nvSpPr>
        <p:spPr>
          <a:xfrm rot="16200000">
            <a:off x="92160" y="5434560"/>
            <a:ext cx="14914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rate per 100,00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individual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 Box 12"/>
          <p:cNvSpPr/>
          <p:nvPr/>
        </p:nvSpPr>
        <p:spPr>
          <a:xfrm>
            <a:off x="1378800" y="4861080"/>
            <a:ext cx="1054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odeling Cance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 Box 13"/>
          <p:cNvSpPr/>
          <p:nvPr/>
        </p:nvSpPr>
        <p:spPr>
          <a:xfrm>
            <a:off x="1447200" y="5286240"/>
            <a:ext cx="728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k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=6,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N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=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 Box 14"/>
          <p:cNvSpPr/>
          <p:nvPr/>
        </p:nvSpPr>
        <p:spPr>
          <a:xfrm>
            <a:off x="1447200" y="5089680"/>
            <a:ext cx="80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k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=5,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N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=4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Line 15"/>
          <p:cNvSpPr/>
          <p:nvPr/>
        </p:nvSpPr>
        <p:spPr>
          <a:xfrm>
            <a:off x="2286000" y="5241960"/>
            <a:ext cx="228600" cy="0"/>
          </a:xfrm>
          <a:prstGeom prst="line">
            <a:avLst/>
          </a:prstGeom>
          <a:ln w="19080">
            <a:solidFill>
              <a:srgbClr val="4f81bd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Line 16"/>
          <p:cNvSpPr/>
          <p:nvPr/>
        </p:nvSpPr>
        <p:spPr>
          <a:xfrm>
            <a:off x="2286000" y="5410080"/>
            <a:ext cx="228600" cy="0"/>
          </a:xfrm>
          <a:prstGeom prst="line">
            <a:avLst/>
          </a:prstGeom>
          <a:ln w="19080">
            <a:solidFill>
              <a:srgbClr val="ff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13"/>
          <p:cNvSpPr/>
          <p:nvPr/>
        </p:nvSpPr>
        <p:spPr>
          <a:xfrm>
            <a:off x="3799440" y="5172120"/>
            <a:ext cx="51109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m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 (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number of crypts per colon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) = 15,000,000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u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  (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mutation rate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) = ~ 1 X 10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6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per gene per divisio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  (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ivisions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) = once every 4 day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Rectangle 14"/>
          <p:cNvSpPr/>
          <p:nvPr/>
        </p:nvSpPr>
        <p:spPr>
          <a:xfrm>
            <a:off x="762120" y="762120"/>
            <a:ext cx="5943600" cy="134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1) </a:t>
            </a:r>
            <a:r>
              <a:rPr b="0" i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   number of required driver mutation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2) </a:t>
            </a:r>
            <a:r>
              <a:rPr b="0" i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m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  number of crypts per colo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3) </a:t>
            </a:r>
            <a:r>
              <a:rPr b="0" i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N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   number of stem cells per crypt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4) </a:t>
            </a:r>
            <a:r>
              <a:rPr b="0" i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u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   mutation rat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5) </a:t>
            </a:r>
            <a:r>
              <a:rPr b="0" i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   divisions since birth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15"/>
          <p:cNvSpPr/>
          <p:nvPr/>
        </p:nvSpPr>
        <p:spPr>
          <a:xfrm>
            <a:off x="313560" y="762120"/>
            <a:ext cx="142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 u="sng">
                <a:solidFill>
                  <a:srgbClr val="000000"/>
                </a:solidFill>
                <a:uFillTx/>
                <a:latin typeface="Arial"/>
                <a:ea typeface="Arial"/>
              </a:rPr>
              <a:t>Parameters: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TextBox 1"/>
          <p:cNvSpPr/>
          <p:nvPr/>
        </p:nvSpPr>
        <p:spPr>
          <a:xfrm>
            <a:off x="457200" y="304920"/>
            <a:ext cx="7812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Evidence of normal mutation and division rate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2"/>
          <p:cNvSpPr/>
          <p:nvPr/>
        </p:nvSpPr>
        <p:spPr>
          <a:xfrm>
            <a:off x="101880" y="685800"/>
            <a:ext cx="8991000" cy="338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The equation demonstrates that colorectal cancers can arise within a lifetime with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relatively normal division and mutation rates. Recent cancer genome sequencing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projects allow an independent test of this conclusion because the actual numbers of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omatic mutations per cancer genome are measured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lthough cancers are thought to have “genomic instability”, the actual number of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omatic mutations detected by cancer genome sequencing projects is generally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&lt; 1 per 100,000 bases (in DNA mismatch repair proficient cancers). By contrast,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the difference between any two unrelated “normal” individuals is about 100-fold greater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nd ~100 SNPs per 100,000 bases. This relatively low frequency of somatic mutation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is consistent with relatively normal mutation and division rates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8" name="Group 2"/>
          <p:cNvGrpSpPr/>
          <p:nvPr/>
        </p:nvGrpSpPr>
        <p:grpSpPr>
          <a:xfrm>
            <a:off x="1566720" y="4050000"/>
            <a:ext cx="2778480" cy="2109960"/>
            <a:chOff x="1566720" y="4050000"/>
            <a:chExt cx="2778480" cy="2109960"/>
          </a:xfrm>
        </p:grpSpPr>
        <p:grpSp>
          <p:nvGrpSpPr>
            <p:cNvPr id="79" name="Group 3"/>
            <p:cNvGrpSpPr/>
            <p:nvPr/>
          </p:nvGrpSpPr>
          <p:grpSpPr>
            <a:xfrm>
              <a:off x="1687320" y="4252680"/>
              <a:ext cx="2505240" cy="1800000"/>
              <a:chOff x="1687320" y="4252680"/>
              <a:chExt cx="2505240" cy="1800000"/>
            </a:xfrm>
          </p:grpSpPr>
          <p:pic>
            <p:nvPicPr>
              <p:cNvPr id="80" name="Picture 4" descr=""/>
              <p:cNvPicPr/>
              <p:nvPr/>
            </p:nvPicPr>
            <p:blipFill>
              <a:blip r:embed="rId1"/>
              <a:stretch/>
            </p:blipFill>
            <p:spPr>
              <a:xfrm>
                <a:off x="1687320" y="4252680"/>
                <a:ext cx="2505240" cy="1800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1" name="Line 5"/>
              <p:cNvSpPr/>
              <p:nvPr/>
            </p:nvSpPr>
            <p:spPr>
              <a:xfrm>
                <a:off x="1982520" y="5338440"/>
                <a:ext cx="2133720" cy="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custDash>
                  <a:ds d="100000" sp="1000"/>
                </a:custDash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82" name="Text Box 6"/>
            <p:cNvSpPr/>
            <p:nvPr/>
          </p:nvSpPr>
          <p:spPr>
            <a:xfrm>
              <a:off x="1949760" y="4354560"/>
              <a:ext cx="1838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Stem Cell Division Rate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Text Box 7"/>
            <p:cNvSpPr/>
            <p:nvPr/>
          </p:nvSpPr>
          <p:spPr>
            <a:xfrm rot="16200000">
              <a:off x="689400" y="4926960"/>
              <a:ext cx="2061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Mutations Per 100,000 BP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Text Box 8"/>
            <p:cNvSpPr/>
            <p:nvPr/>
          </p:nvSpPr>
          <p:spPr>
            <a:xfrm>
              <a:off x="1983960" y="4770360"/>
              <a:ext cx="88020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division 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everyday 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Text Box 9"/>
            <p:cNvSpPr/>
            <p:nvPr/>
          </p:nvSpPr>
          <p:spPr>
            <a:xfrm>
              <a:off x="3050280" y="4786200"/>
              <a:ext cx="129492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division 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every four days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Line 10"/>
            <p:cNvSpPr/>
            <p:nvPr/>
          </p:nvSpPr>
          <p:spPr>
            <a:xfrm>
              <a:off x="2668320" y="4998960"/>
              <a:ext cx="30492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Line 11"/>
            <p:cNvSpPr/>
            <p:nvPr/>
          </p:nvSpPr>
          <p:spPr>
            <a:xfrm flipH="1">
              <a:off x="3277800" y="5319720"/>
              <a:ext cx="7596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Text Box 12"/>
            <p:cNvSpPr/>
            <p:nvPr/>
          </p:nvSpPr>
          <p:spPr>
            <a:xfrm>
              <a:off x="2963520" y="5852880"/>
              <a:ext cx="438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age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9" name="TextBox 14"/>
          <p:cNvSpPr/>
          <p:nvPr/>
        </p:nvSpPr>
        <p:spPr>
          <a:xfrm>
            <a:off x="4748400" y="4267080"/>
            <a:ext cx="27428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ssuming a mutation rate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of 10</a:t>
            </a:r>
            <a:r>
              <a:rPr b="0" lang="en-US" sz="1800" spc="-1" strike="noStrike" baseline="30000">
                <a:solidFill>
                  <a:srgbClr val="000000"/>
                </a:solidFill>
                <a:latin typeface="Calibri"/>
              </a:rPr>
              <a:t>-9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per base per divisio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Right Brace 15"/>
          <p:cNvSpPr/>
          <p:nvPr/>
        </p:nvSpPr>
        <p:spPr>
          <a:xfrm>
            <a:off x="4343400" y="5334120"/>
            <a:ext cx="304920" cy="457200"/>
          </a:xfrm>
          <a:custGeom>
            <a:avLst/>
            <a:gdLst>
              <a:gd name="textAreaLeft" fmla="*/ 0 w 304920"/>
              <a:gd name="textAreaRight" fmla="*/ 110160 w 304920"/>
              <a:gd name="textAreaTop" fmla="*/ 7920 h 457200"/>
              <a:gd name="textAreaBottom" fmla="*/ 449280 h 4572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600"/>
                  <a:pt x="10800" y="1200"/>
                </a:cubicBezTo>
                <a:lnTo>
                  <a:pt x="10800" y="9600"/>
                </a:lnTo>
                <a:cubicBezTo>
                  <a:pt x="10800" y="10200"/>
                  <a:pt x="16200" y="10800"/>
                  <a:pt x="21600" y="10800"/>
                </a:cubicBezTo>
                <a:cubicBezTo>
                  <a:pt x="16200" y="10800"/>
                  <a:pt x="10800" y="11400"/>
                  <a:pt x="10800" y="12000"/>
                </a:cubicBezTo>
                <a:lnTo>
                  <a:pt x="10800" y="20400"/>
                </a:lnTo>
                <a:cubicBezTo>
                  <a:pt x="10800" y="210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Box 16"/>
          <p:cNvSpPr/>
          <p:nvPr/>
        </p:nvSpPr>
        <p:spPr>
          <a:xfrm>
            <a:off x="4583880" y="5257800"/>
            <a:ext cx="21225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mutation frequencie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ound in cancer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TextBox 1"/>
          <p:cNvSpPr/>
          <p:nvPr/>
        </p:nvSpPr>
        <p:spPr>
          <a:xfrm>
            <a:off x="457200" y="304920"/>
            <a:ext cx="7812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Conclusion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Box 2"/>
          <p:cNvSpPr/>
          <p:nvPr/>
        </p:nvSpPr>
        <p:spPr>
          <a:xfrm>
            <a:off x="161640" y="914400"/>
            <a:ext cx="8855280" cy="228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The equation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= 1 - (1 - (1 - (1 -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u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)</a:t>
            </a:r>
            <a:r>
              <a:rPr b="0" i="1" lang="en-US" sz="1800" spc="-1" strike="noStrike" baseline="30000">
                <a:solidFill>
                  <a:srgbClr val="000000"/>
                </a:solidFill>
                <a:latin typeface="Calibri"/>
              </a:rPr>
              <a:t>d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)</a:t>
            </a:r>
            <a:r>
              <a:rPr b="0" i="1" lang="en-US" sz="1800" spc="-1" strike="noStrike" baseline="30000">
                <a:solidFill>
                  <a:srgbClr val="000000"/>
                </a:solidFill>
                <a:latin typeface="Calibri"/>
              </a:rPr>
              <a:t>k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)</a:t>
            </a:r>
            <a:r>
              <a:rPr b="0" i="1" lang="en-US" sz="1800" spc="-1" strike="noStrike" baseline="30000">
                <a:solidFill>
                  <a:srgbClr val="000000"/>
                </a:solidFill>
                <a:latin typeface="Calibri"/>
              </a:rPr>
              <a:t>Nm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illustrates that cancers can arise at rates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matching human cancer epidemiology with relatively normal mutation and divisio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rates. The manuscript illustrates how small variations in the parameters can predic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the relatively risks seen with greater height, germline APC mutations, aspirin use,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nd ulcerative colitis. Although this equation does not encompass all of the complexity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f cancer (especially changes that occur during aging and with mutation), it may serv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s a “beginners” guide to demonstrate how different biological cancer features may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e related. 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8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2-22T23:37:25Z</dcterms:created>
  <dc:creator>darryl shibata</dc:creator>
  <dc:description/>
  <dc:language>en-US</dc:language>
  <cp:lastModifiedBy>darryl shibata</cp:lastModifiedBy>
  <dcterms:modified xsi:type="dcterms:W3CDTF">2010-01-12T05:48:42Z</dcterms:modified>
  <cp:revision>7</cp:revision>
  <dc:subject/>
  <dc:title>Slide 1</dc:title>
</cp:coreProperties>
</file>